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9"/>
  </p:notesMasterIdLst>
  <p:sldIdLst>
    <p:sldId id="9001" r:id="rId2"/>
    <p:sldId id="9002" r:id="rId3"/>
    <p:sldId id="9003" r:id="rId4"/>
    <p:sldId id="9004" r:id="rId5"/>
    <p:sldId id="9005" r:id="rId6"/>
    <p:sldId id="9006" r:id="rId7"/>
    <p:sldId id="9007" r:id="rId8"/>
    <p:sldId id="9008" r:id="rId9"/>
    <p:sldId id="9009" r:id="rId10"/>
    <p:sldId id="9010" r:id="rId11"/>
    <p:sldId id="9011" r:id="rId12"/>
    <p:sldId id="9012" r:id="rId13"/>
    <p:sldId id="9013" r:id="rId14"/>
    <p:sldId id="9014" r:id="rId15"/>
    <p:sldId id="9015" r:id="rId16"/>
    <p:sldId id="9016" r:id="rId17"/>
    <p:sldId id="9017" r:id="rId18"/>
    <p:sldId id="9018" r:id="rId19"/>
    <p:sldId id="9019" r:id="rId20"/>
    <p:sldId id="9020" r:id="rId21"/>
    <p:sldId id="9021" r:id="rId22"/>
    <p:sldId id="9022" r:id="rId23"/>
    <p:sldId id="9023" r:id="rId24"/>
    <p:sldId id="9024" r:id="rId25"/>
    <p:sldId id="9025" r:id="rId26"/>
    <p:sldId id="9026" r:id="rId27"/>
    <p:sldId id="9027" r:id="rId28"/>
    <p:sldId id="9028" r:id="rId29"/>
    <p:sldId id="9029" r:id="rId30"/>
    <p:sldId id="9030" r:id="rId31"/>
    <p:sldId id="9031" r:id="rId32"/>
    <p:sldId id="9032" r:id="rId33"/>
    <p:sldId id="9033" r:id="rId34"/>
    <p:sldId id="9034" r:id="rId35"/>
    <p:sldId id="9035" r:id="rId36"/>
    <p:sldId id="9036" r:id="rId37"/>
    <p:sldId id="9037" r:id="rId38"/>
    <p:sldId id="9038" r:id="rId39"/>
    <p:sldId id="9039" r:id="rId40"/>
    <p:sldId id="9040" r:id="rId41"/>
    <p:sldId id="9041" r:id="rId42"/>
    <p:sldId id="9042" r:id="rId43"/>
    <p:sldId id="9043" r:id="rId44"/>
    <p:sldId id="9044" r:id="rId45"/>
    <p:sldId id="9045" r:id="rId46"/>
    <p:sldId id="9046" r:id="rId47"/>
    <p:sldId id="9047" r:id="rId48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144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54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8" Type="http://schemas.openxmlformats.org/officeDocument/2006/relationships/slide" Target="slides/slide7.xml"/><Relationship Id="rId51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9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/>
          </a:p>
        </p:txBody>
      </p:sp>
      <p:sp>
        <p:nvSpPr>
          <p:cNvPr id="3789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FB133562-DB70-4489-B902-C7187B579CB1}" type="datetimeFigureOut">
              <a:rPr lang="en-US"/>
              <a:pPr/>
              <a:t>8/31/2017</a:t>
            </a:fld>
            <a:endParaRPr lang="en-US"/>
          </a:p>
        </p:txBody>
      </p:sp>
      <p:sp>
        <p:nvSpPr>
          <p:cNvPr id="3789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43000" y="685800"/>
            <a:ext cx="45720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</p:spPr>
      </p:sp>
      <p:sp>
        <p:nvSpPr>
          <p:cNvPr id="37893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37894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/>
          </a:p>
        </p:txBody>
      </p:sp>
      <p:sp>
        <p:nvSpPr>
          <p:cNvPr id="37895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2A272E5E-FDA7-4C2E-AD94-281D6A186C74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457200" y="6245225"/>
            <a:ext cx="2133600" cy="476250"/>
          </a:xfrm>
        </p:spPr>
        <p:txBody>
          <a:bodyPr/>
          <a:lstStyle>
            <a:lvl1pPr>
              <a:defRPr/>
            </a:lvl1pPr>
          </a:lstStyle>
          <a:p>
            <a:fld id="{6684F361-2ADF-41EF-B41F-325014BD7694}" type="datetime1">
              <a:rPr lang="en-US"/>
              <a:pPr/>
              <a:t>8/3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5619750" y="0"/>
            <a:ext cx="3524250" cy="5334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This is a test header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6553200" y="6245225"/>
            <a:ext cx="2133600" cy="476250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9C1725E-6BDC-4C95-BD1A-49E20A24670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fld id="{4FB3694C-B38A-4554-9681-E97BA90B0E1B}" type="datetime1">
              <a:rPr lang="en-US"/>
              <a:pPr/>
              <a:t>8/31/2017</a:t>
            </a:fld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5619750" y="0"/>
            <a:ext cx="3524250" cy="53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1" i="1"/>
            </a:lvl1pPr>
          </a:lstStyle>
          <a:p>
            <a:r>
              <a:rPr lang="en-US"/>
              <a:t>This is a test header</a:t>
            </a: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3AB2AAF7-0AE3-46E9-8ACF-FBDF34410FA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hf sldNum="0" hd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gif"/><Relationship Id="rId2" Type="http://schemas.openxmlformats.org/officeDocument/2006/relationships/image" Target="../media/image14.gi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gif"/><Relationship Id="rId2" Type="http://schemas.openxmlformats.org/officeDocument/2006/relationships/image" Target="../media/image15.gi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gi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gif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gi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gif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gif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gif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gif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g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3.gif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gif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gif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gif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gif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gif"/><Relationship Id="rId2" Type="http://schemas.openxmlformats.org/officeDocument/2006/relationships/image" Target="../media/image28.gif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gif"/><Relationship Id="rId2" Type="http://schemas.openxmlformats.org/officeDocument/2006/relationships/image" Target="../media/image30.gif"/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gif"/><Relationship Id="rId2" Type="http://schemas.openxmlformats.org/officeDocument/2006/relationships/image" Target="../media/image32.gif"/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gif"/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gif"/><Relationship Id="rId2" Type="http://schemas.openxmlformats.org/officeDocument/2006/relationships/image" Target="../media/image35.gif"/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gif"/><Relationship Id="rId2" Type="http://schemas.openxmlformats.org/officeDocument/2006/relationships/image" Target="../media/image37.g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gif"/><Relationship Id="rId2" Type="http://schemas.openxmlformats.org/officeDocument/2006/relationships/image" Target="../media/image4.gif"/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gif"/><Relationship Id="rId2" Type="http://schemas.openxmlformats.org/officeDocument/2006/relationships/image" Target="../media/image38.gif"/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gif"/><Relationship Id="rId2" Type="http://schemas.openxmlformats.org/officeDocument/2006/relationships/image" Target="../media/image40.gif"/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gif"/><Relationship Id="rId2" Type="http://schemas.openxmlformats.org/officeDocument/2006/relationships/image" Target="../media/image41.gif"/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gif"/><Relationship Id="rId2" Type="http://schemas.openxmlformats.org/officeDocument/2006/relationships/image" Target="../media/image42.gif"/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gif"/><Relationship Id="rId2" Type="http://schemas.openxmlformats.org/officeDocument/2006/relationships/image" Target="../media/image43.gif"/><Relationship Id="rId1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gif"/><Relationship Id="rId2" Type="http://schemas.openxmlformats.org/officeDocument/2006/relationships/image" Target="../media/image44.gif"/><Relationship Id="rId1" Type="http://schemas.openxmlformats.org/officeDocument/2006/relationships/slideLayout" Target="../slideLayouts/slideLayout1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gif"/><Relationship Id="rId1" Type="http://schemas.openxmlformats.org/officeDocument/2006/relationships/slideLayout" Target="../slideLayouts/slideLayout1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gif"/><Relationship Id="rId2" Type="http://schemas.openxmlformats.org/officeDocument/2006/relationships/image" Target="../media/image47.g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9.gif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gif"/><Relationship Id="rId1" Type="http://schemas.openxmlformats.org/officeDocument/2006/relationships/slideLayout" Target="../slideLayouts/slideLayout1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gif"/><Relationship Id="rId2" Type="http://schemas.openxmlformats.org/officeDocument/2006/relationships/image" Target="../media/image51.g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3.g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gif"/><Relationship Id="rId2" Type="http://schemas.openxmlformats.org/officeDocument/2006/relationships/image" Target="../media/image6.gif"/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gif"/><Relationship Id="rId1" Type="http://schemas.openxmlformats.org/officeDocument/2006/relationships/slideLayout" Target="../slideLayouts/slideLayout1.xml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gif"/><Relationship Id="rId2" Type="http://schemas.openxmlformats.org/officeDocument/2006/relationships/image" Target="../media/image55.g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7.gif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gif"/><Relationship Id="rId1" Type="http://schemas.openxmlformats.org/officeDocument/2006/relationships/slideLayout" Target="../slideLayouts/slideLayout1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gif"/><Relationship Id="rId1" Type="http://schemas.openxmlformats.org/officeDocument/2006/relationships/slideLayout" Target="../slideLayouts/slideLayout1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gif"/><Relationship Id="rId1" Type="http://schemas.openxmlformats.org/officeDocument/2006/relationships/slideLayout" Target="../slideLayouts/slideLayout1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gif"/><Relationship Id="rId1" Type="http://schemas.openxmlformats.org/officeDocument/2006/relationships/slideLayout" Target="../slideLayouts/slideLayout1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gif"/><Relationship Id="rId1" Type="http://schemas.openxmlformats.org/officeDocument/2006/relationships/slideLayout" Target="../slideLayouts/slideLayout1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gi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gif"/><Relationship Id="rId2" Type="http://schemas.openxmlformats.org/officeDocument/2006/relationships/image" Target="../media/image7.gi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gif"/><Relationship Id="rId2" Type="http://schemas.openxmlformats.org/officeDocument/2006/relationships/image" Target="../media/image9.gi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gif"/><Relationship Id="rId2" Type="http://schemas.openxmlformats.org/officeDocument/2006/relationships/image" Target="../media/image10.gi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gif"/><Relationship Id="rId2" Type="http://schemas.openxmlformats.org/officeDocument/2006/relationships/image" Target="../media/image12.gi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gif"/><Relationship Id="rId2" Type="http://schemas.openxmlformats.org/officeDocument/2006/relationships/image" Target="../media/image13.g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76350"/>
            <a:ext cx="5486400" cy="287655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48150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47775"/>
            <a:ext cx="5486400" cy="293370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76725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85875"/>
            <a:ext cx="5486400" cy="2867025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48150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905000" y="1695450"/>
            <a:ext cx="5238750" cy="327660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905000" y="1695450"/>
            <a:ext cx="5238750" cy="327660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905000" y="1695450"/>
            <a:ext cx="5238750" cy="327660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905000" y="1695450"/>
            <a:ext cx="5238750" cy="327660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905000" y="1695450"/>
            <a:ext cx="5238750" cy="327660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905000" y="1695450"/>
            <a:ext cx="5238750" cy="327660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00300" y="2409825"/>
            <a:ext cx="4238625" cy="184785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00300" y="2409825"/>
            <a:ext cx="4238625" cy="184785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304925"/>
            <a:ext cx="5486400" cy="2828925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29100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00300" y="2409825"/>
            <a:ext cx="4238625" cy="184785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00300" y="2409825"/>
            <a:ext cx="4238625" cy="184785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00300" y="2409825"/>
            <a:ext cx="4238625" cy="184785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00300" y="2409825"/>
            <a:ext cx="4238625" cy="184785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562100"/>
            <a:ext cx="5486400" cy="3076575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733925"/>
            <a:ext cx="5229225" cy="36195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571625"/>
            <a:ext cx="5486400" cy="306705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733925"/>
            <a:ext cx="5229225" cy="36195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571625"/>
            <a:ext cx="5486400" cy="306705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733925"/>
            <a:ext cx="5229225" cy="36195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95250" y="1476375"/>
            <a:ext cx="10553700" cy="371475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76350"/>
            <a:ext cx="5486400" cy="287655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48150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76350"/>
            <a:ext cx="5486400" cy="287655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48150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304925"/>
            <a:ext cx="5486400" cy="2828925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29100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76350"/>
            <a:ext cx="5486400" cy="287655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48150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76350"/>
            <a:ext cx="5486400" cy="287655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48150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76350"/>
            <a:ext cx="5486400" cy="287655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48150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57300"/>
            <a:ext cx="5486400" cy="2924175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76725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76350"/>
            <a:ext cx="5486400" cy="287655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48150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76350"/>
            <a:ext cx="5486400" cy="287655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48150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371725" y="619125"/>
            <a:ext cx="4292420" cy="595312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85875"/>
            <a:ext cx="5486400" cy="335280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162175" y="4733925"/>
            <a:ext cx="4714875" cy="161925"/>
          </a:xfrm>
          <a:prstGeom prst="rect">
            <a:avLst/>
          </a:prstGeom>
          <a:noFill/>
        </p:spPr>
      </p:pic>
      <p:pic>
        <p:nvPicPr>
          <p:cNvPr id="254" name="Picture 3" descr="Data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647950" y="4991100"/>
            <a:ext cx="3752850" cy="38100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247900" y="1971675"/>
            <a:ext cx="4543425" cy="272415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85875"/>
            <a:ext cx="5486400" cy="335280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162175" y="4733925"/>
            <a:ext cx="4714875" cy="161925"/>
          </a:xfrm>
          <a:prstGeom prst="rect">
            <a:avLst/>
          </a:prstGeom>
          <a:noFill/>
        </p:spPr>
      </p:pic>
      <p:pic>
        <p:nvPicPr>
          <p:cNvPr id="254" name="Picture 3" descr="Data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647950" y="4991100"/>
            <a:ext cx="3752850" cy="38100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304925"/>
            <a:ext cx="5486400" cy="2828925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29100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247900" y="1971675"/>
            <a:ext cx="4543425" cy="272415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95400"/>
            <a:ext cx="5486400" cy="333375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162175" y="4724400"/>
            <a:ext cx="4714875" cy="161925"/>
          </a:xfrm>
          <a:prstGeom prst="rect">
            <a:avLst/>
          </a:prstGeom>
          <a:noFill/>
        </p:spPr>
      </p:pic>
      <p:pic>
        <p:nvPicPr>
          <p:cNvPr id="254" name="Picture 3" descr="Data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647950" y="4981575"/>
            <a:ext cx="3752850" cy="38100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247900" y="1971675"/>
            <a:ext cx="4543425" cy="272415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914525" y="2162175"/>
            <a:ext cx="5219700" cy="233362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962150" y="2047875"/>
            <a:ext cx="5124450" cy="257175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81100" y="1343025"/>
            <a:ext cx="6686550" cy="3981450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24000" y="619125"/>
            <a:ext cx="5987536" cy="595312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905000" y="952500"/>
            <a:ext cx="5238750" cy="47529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66825"/>
            <a:ext cx="5486400" cy="289560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57675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76350"/>
            <a:ext cx="5486400" cy="287655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48150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85875"/>
            <a:ext cx="5486400" cy="285750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38625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66825"/>
            <a:ext cx="5486400" cy="2895600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57675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 wrap="none">
            <a:spAutoFit/>
          </a:bodyPr>
          <a:lstStyle/>
          <a:p>
            <a:r>
              <a:rPr lang="en-US"/>
              <a:t>Modeled Health-Economics Results -- Puerto Rico</a:t>
            </a:r>
          </a:p>
        </p:txBody>
      </p:sp>
      <p:pic>
        <p:nvPicPr>
          <p:cNvPr id="252" name="Picture 1" descr="Data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81175" y="1295400"/>
            <a:ext cx="5486400" cy="2847975"/>
          </a:xfrm>
          <a:prstGeom prst="rect">
            <a:avLst/>
          </a:prstGeom>
          <a:noFill/>
        </p:spPr>
      </p:pic>
      <p:pic>
        <p:nvPicPr>
          <p:cNvPr id="253" name="Picture 2" descr="Data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05000" y="4238625"/>
            <a:ext cx="5229225" cy="1133475"/>
          </a:xfrm>
          <a:prstGeom prst="rect">
            <a:avLst/>
          </a:prstGeom>
          <a:noFill/>
        </p:spPr>
      </p:pic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5250" y="95250"/>
            <a:ext cx="95250" cy="95250"/>
          </a:xfrm>
        </p:spPr>
        <p:txBody>
          <a:bodyPr/>
          <a:lstStyle/>
          <a:p>
            <a:r>
              <a:rPr lang="en-US"/>
              <a:t>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Words>329</Words>
  <Application>Microsoft Office PowerPoint</Application>
  <PresentationFormat>On-screen Show (4:3)</PresentationFormat>
  <Paragraphs>94</Paragraphs>
  <Slides>4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7</vt:i4>
      </vt:variant>
    </vt:vector>
  </HeadingPairs>
  <TitlesOfParts>
    <vt:vector size="50" baseType="lpstr">
      <vt:lpstr>Arial</vt:lpstr>
      <vt:lpstr>Calibri</vt:lpstr>
      <vt:lpstr>Default Design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  <vt:lpstr> </vt:lpstr>
    </vt:vector>
  </TitlesOfParts>
  <Company>Merck &amp; Co.,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o Title</dc:title>
  <dc:creator>Merck</dc:creator>
  <cp:lastModifiedBy>JESLIE M RAMOS CARTAGENA</cp:lastModifiedBy>
  <cp:revision>3</cp:revision>
  <dcterms:created xsi:type="dcterms:W3CDTF">2008-03-07T01:24:04Z</dcterms:created>
  <dcterms:modified xsi:type="dcterms:W3CDTF">2017-08-31T18:52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-929734118</vt:i4>
  </property>
  <property fmtid="{D5CDD505-2E9C-101B-9397-08002B2CF9AE}" pid="3" name="_NewReviewCycle">
    <vt:lpwstr/>
  </property>
  <property fmtid="{D5CDD505-2E9C-101B-9397-08002B2CF9AE}" pid="4" name="_EmailSubject">
    <vt:lpwstr>PLOS ONE: Your submission PONE-D-16-40953R1 - [EMID:8aa76da4e1a03134]</vt:lpwstr>
  </property>
  <property fmtid="{D5CDD505-2E9C-101B-9397-08002B2CF9AE}" pid="5" name="_AuthorEmail">
    <vt:lpwstr>homero_monsanto@merck.com</vt:lpwstr>
  </property>
  <property fmtid="{D5CDD505-2E9C-101B-9397-08002B2CF9AE}" pid="6" name="_AuthorEmailDisplayName">
    <vt:lpwstr>Monsanto, Homero (PRCRHH)</vt:lpwstr>
  </property>
  <property fmtid="{D5CDD505-2E9C-101B-9397-08002B2CF9AE}" pid="7" name="_PreviousAdHocReviewCycleID">
    <vt:i4>-438753611</vt:i4>
  </property>
</Properties>
</file>